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4694"/>
  </p:normalViewPr>
  <p:slideViewPr>
    <p:cSldViewPr snapToGrid="0" snapToObjects="1">
      <p:cViewPr varScale="1">
        <p:scale>
          <a:sx n="92" d="100"/>
          <a:sy n="92" d="100"/>
        </p:scale>
        <p:origin x="46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BEE5-875D-8946-A63D-81DE2B46BA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A618F4-A7B3-5A4A-9C9A-5323D78D2F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9E8A4D-CF68-EB41-A878-B554875AA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AF75C-11C5-354E-AB0D-E691B7469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376B76-9BB0-5A4C-8939-1441CC83C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807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A48C1-4B62-F74A-BD96-B7567CF66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E82A98-B1B9-D844-9701-8E4A9390ED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54770-57AA-1042-B07A-F8A507E2F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107D0-C4DC-F944-A0B3-125DEE2D8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7B6E28-EFAE-9C42-AF2B-2CA097CF2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87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557279-376D-EE49-A27E-9EDDE61784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7FE977-08AB-D741-9929-331F2C2C4B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A18A76-1A54-3D47-BACD-712963904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15EDA-6B92-0341-B672-3681A555F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C3EFFA-5D2B-A24A-B6C8-7F1E03F9F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064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19D50-F530-3B4C-A380-B473776EF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33D1CB-6FD1-FE44-BB53-A519880F8D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6FA020-B1AC-A642-A450-6B4C25BAC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CAE69-3789-8046-8849-378420BAF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2AE27-5553-1D49-8EED-4CC3FE76D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495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87B38-B823-B642-B366-F2AB10BD6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641F19-78A6-BB48-8D76-430FA6D572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B5A3F-3D25-2241-87F2-5C4C0A48E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5D53A-9052-4445-9BC9-6239D8D2F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C12FAA-F473-8F44-9C35-7990F4EC5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585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AF440-B0A1-D246-9559-1CA7C306B2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7B1669-8771-D74D-BE03-75394608C0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626756-987E-7141-807D-E2235D83B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FFA1B0-28A2-104A-9E92-76CEF3FBD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C129B4-CF25-C144-B6B7-4F1525F3D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C64019-90E1-614B-9C4A-95A910EA8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830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4563C-0AA4-9342-9094-E10FB2B617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9BAAE8-7ADF-544A-BF8B-19D6A2EA6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8481DA-B93E-754B-9204-BF47866CE9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C2FD46-0E67-3F4E-B007-6934215DB1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8BAE98-4EDF-BB4F-8615-53872528BC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F23157-B06B-6144-9558-6B3FE9BA2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5AF0E1-29AE-7040-9733-6985E776D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4C78EA-DB1A-F443-BB13-10B446578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469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E42A3-78B9-C342-B5B6-8FD50D64E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85FCB7-7625-754C-8451-6A00274F5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22F3A6-3437-F84E-8DDC-70B0E015E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725A85-C4FA-DC41-A530-504EFE5EF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715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0B7D17-46B7-194D-8B4A-79214867E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60023F-46B9-3640-9316-E6B58E531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85882F-AC8D-1542-A603-4C615B95C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400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EBA808-5B52-084E-8E59-5DB57AF0F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6D28FF-D262-1840-AA1A-C60E185B5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4D22CE-4677-AC43-B433-8E5C0B37B1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4F9C8-8473-6F4A-BCD9-363596ED8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B7ABCE-6B9C-DB43-BBDB-7D10D7C93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EAD61F-9387-4640-98AC-C242D8E05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670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0F59B-35BE-6E4D-A389-362EDA6E4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189F66-E56B-8547-BA1C-FF578AD1EA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580A6F-A77A-6448-A2F1-467FAFD78B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59FB5A-39DE-DF43-A03B-0E377FD48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634A5-23F4-C54D-95C2-2DAB80281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E02E0-1BE0-4E46-9080-6913B3342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85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95039F-C2C6-5C42-AE55-CB20E3CB0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936CEF-5C55-044C-934E-D08344D1CA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A1E5BE-D252-AD49-BED2-49DC5272A6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9F827-222F-1545-8AB9-9EBA8DAE5299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0D5AD6-2348-0846-94D9-5B5B47DA7D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11C45D-61F7-9848-BF4D-41DD693B1C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D1F73-CFB4-BF46-B07F-3E25AB2FB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851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86C71CF-1A7D-CE4D-8AFA-8A83A14F24C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561" t="15742" r="7299" b="52031"/>
          <a:stretch/>
        </p:blipFill>
        <p:spPr>
          <a:xfrm>
            <a:off x="5394370" y="4245447"/>
            <a:ext cx="3411503" cy="734318"/>
          </a:xfrm>
          <a:prstGeom prst="rect">
            <a:avLst/>
          </a:prstGeom>
          <a:ln w="28575">
            <a:solidFill>
              <a:prstClr val="black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713594E-F58C-A24C-BB35-9F855FE06F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4373" y="2401080"/>
            <a:ext cx="3411499" cy="533552"/>
          </a:xfrm>
          <a:prstGeom prst="rect">
            <a:avLst/>
          </a:prstGeom>
          <a:ln w="28575">
            <a:solidFill>
              <a:prstClr val="black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46B62E2-B669-6346-8579-A4A05CA3EEC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646" t="4757" r="7537" b="79471"/>
          <a:stretch/>
        </p:blipFill>
        <p:spPr>
          <a:xfrm>
            <a:off x="5394370" y="3027498"/>
            <a:ext cx="3411502" cy="565049"/>
          </a:xfrm>
          <a:prstGeom prst="rect">
            <a:avLst/>
          </a:prstGeom>
          <a:ln w="28575">
            <a:solidFill>
              <a:prstClr val="black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DF1FF1D-7ADF-E64F-AF96-FDFE59EF20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94370" y="3685413"/>
            <a:ext cx="3411505" cy="467168"/>
          </a:xfrm>
          <a:prstGeom prst="rect">
            <a:avLst/>
          </a:prstGeom>
          <a:ln w="28575">
            <a:solidFill>
              <a:prstClr val="black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86927B1-94E8-3D40-A425-BBA6F8A00786}"/>
              </a:ext>
            </a:extLst>
          </p:cNvPr>
          <p:cNvSpPr txBox="1"/>
          <p:nvPr/>
        </p:nvSpPr>
        <p:spPr>
          <a:xfrm>
            <a:off x="4323732" y="2442619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D026E7-E92F-404F-A0C6-EFC2AD1FDADB}"/>
              </a:ext>
            </a:extLst>
          </p:cNvPr>
          <p:cNvSpPr txBox="1"/>
          <p:nvPr/>
        </p:nvSpPr>
        <p:spPr>
          <a:xfrm>
            <a:off x="4323733" y="3100486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0CF687-11A5-994A-AC2F-3EF14A491256}"/>
              </a:ext>
            </a:extLst>
          </p:cNvPr>
          <p:cNvSpPr txBox="1"/>
          <p:nvPr/>
        </p:nvSpPr>
        <p:spPr>
          <a:xfrm>
            <a:off x="4323732" y="3680351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00598C7-D5F1-F140-B47E-0EA029DF16CC}"/>
              </a:ext>
            </a:extLst>
          </p:cNvPr>
          <p:cNvSpPr txBox="1"/>
          <p:nvPr/>
        </p:nvSpPr>
        <p:spPr>
          <a:xfrm>
            <a:off x="4145991" y="4338218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9C9DB5-25B2-CE48-80B0-E38EE8C17D98}"/>
              </a:ext>
            </a:extLst>
          </p:cNvPr>
          <p:cNvSpPr txBox="1"/>
          <p:nvPr/>
        </p:nvSpPr>
        <p:spPr>
          <a:xfrm>
            <a:off x="350728" y="225434"/>
            <a:ext cx="4011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BET siRNA, 48 hour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5253877-4E75-CE4D-80E6-D96B871EB178}"/>
              </a:ext>
            </a:extLst>
          </p:cNvPr>
          <p:cNvSpPr txBox="1"/>
          <p:nvPr/>
        </p:nvSpPr>
        <p:spPr>
          <a:xfrm rot="18761051">
            <a:off x="5594540" y="1564013"/>
            <a:ext cx="8867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6DA1F0B-3755-EE40-A8C6-3CADF28DA5CF}"/>
              </a:ext>
            </a:extLst>
          </p:cNvPr>
          <p:cNvSpPr txBox="1"/>
          <p:nvPr/>
        </p:nvSpPr>
        <p:spPr>
          <a:xfrm rot="18761051">
            <a:off x="6408777" y="1497128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28A987-2B01-A44E-80E3-D9705C3C8D47}"/>
              </a:ext>
            </a:extLst>
          </p:cNvPr>
          <p:cNvSpPr txBox="1"/>
          <p:nvPr/>
        </p:nvSpPr>
        <p:spPr>
          <a:xfrm rot="18761051">
            <a:off x="7146149" y="1497129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F77D2E-6CAD-5B44-A977-72A566FDAEE9}"/>
              </a:ext>
            </a:extLst>
          </p:cNvPr>
          <p:cNvSpPr txBox="1"/>
          <p:nvPr/>
        </p:nvSpPr>
        <p:spPr>
          <a:xfrm rot="18761051">
            <a:off x="8017683" y="1499828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4</a:t>
            </a:r>
          </a:p>
        </p:txBody>
      </p:sp>
    </p:spTree>
    <p:extLst>
      <p:ext uri="{BB962C8B-B14F-4D97-AF65-F5344CB8AC3E}">
        <p14:creationId xmlns:p14="http://schemas.microsoft.com/office/powerpoint/2010/main" val="23280893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99C9DB5-25B2-CE48-80B0-E38EE8C17D98}"/>
              </a:ext>
            </a:extLst>
          </p:cNvPr>
          <p:cNvSpPr txBox="1"/>
          <p:nvPr/>
        </p:nvSpPr>
        <p:spPr>
          <a:xfrm>
            <a:off x="350728" y="225434"/>
            <a:ext cx="4241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BRD4 siRNA, 48 hou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B8AAC99-045E-4803-BC62-5FD92D975D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5500" y="2005012"/>
            <a:ext cx="8001000" cy="2847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7700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99C9DB5-25B2-CE48-80B0-E38EE8C17D98}"/>
              </a:ext>
            </a:extLst>
          </p:cNvPr>
          <p:cNvSpPr txBox="1"/>
          <p:nvPr/>
        </p:nvSpPr>
        <p:spPr>
          <a:xfrm>
            <a:off x="350728" y="225434"/>
            <a:ext cx="4241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BRD3 siRNA, 48 hou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EAC60F1-AF35-412F-AC76-A4548FDB27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4725" y="1214437"/>
            <a:ext cx="5162550" cy="4429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175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99C9DB5-25B2-CE48-80B0-E38EE8C17D98}"/>
              </a:ext>
            </a:extLst>
          </p:cNvPr>
          <p:cNvSpPr txBox="1"/>
          <p:nvPr/>
        </p:nvSpPr>
        <p:spPr>
          <a:xfrm>
            <a:off x="350728" y="225434"/>
            <a:ext cx="4241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BRD2 siRNA, 48 hou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480A062-17C9-4E9D-A4FD-62927B62AA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2800" y="1454129"/>
            <a:ext cx="5486400" cy="4505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355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99C9DB5-25B2-CE48-80B0-E38EE8C17D98}"/>
              </a:ext>
            </a:extLst>
          </p:cNvPr>
          <p:cNvSpPr txBox="1"/>
          <p:nvPr/>
        </p:nvSpPr>
        <p:spPr>
          <a:xfrm>
            <a:off x="350728" y="225434"/>
            <a:ext cx="44140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Tubulin siRNA, 48 hou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2E9F74D-FC1A-4804-AB1D-A7DF4B6D1F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3212" y="1738312"/>
            <a:ext cx="6505575" cy="3381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8168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43</Words>
  <Application>Microsoft Office PowerPoint</Application>
  <PresentationFormat>Widescreen</PresentationFormat>
  <Paragraphs>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4</cp:revision>
  <dcterms:created xsi:type="dcterms:W3CDTF">2020-03-26T01:05:33Z</dcterms:created>
  <dcterms:modified xsi:type="dcterms:W3CDTF">2020-04-13T01:24:08Z</dcterms:modified>
</cp:coreProperties>
</file>